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5A9F937-45EB-B44D-984A-57074389ADD2}" v="2" dt="2024-01-12T12:16:29.285"/>
    <p1510:client id="{F6FB32E6-F912-C242-8F3D-17E71D9B1660}" v="1" dt="2024-01-12T11:56:02.08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7" autoAdjust="0"/>
    <p:restoredTop sz="94660"/>
  </p:normalViewPr>
  <p:slideViewPr>
    <p:cSldViewPr snapToGrid="0">
      <p:cViewPr>
        <p:scale>
          <a:sx n="85" d="100"/>
          <a:sy n="85" d="100"/>
        </p:scale>
        <p:origin x="672" y="10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i PAN (20567662)" userId="bcbb93bd-4ab9-4583-a92c-85cf909a14d6" providerId="ADAL" clId="{F6FB32E6-F912-C242-8F3D-17E71D9B1660}"/>
    <pc:docChg chg="custSel modSld">
      <pc:chgData name="Qi PAN (20567662)" userId="bcbb93bd-4ab9-4583-a92c-85cf909a14d6" providerId="ADAL" clId="{F6FB32E6-F912-C242-8F3D-17E71D9B1660}" dt="2024-01-12T11:56:09.701" v="5" actId="1076"/>
      <pc:docMkLst>
        <pc:docMk/>
      </pc:docMkLst>
      <pc:sldChg chg="addSp delSp modSp mod">
        <pc:chgData name="Qi PAN (20567662)" userId="bcbb93bd-4ab9-4583-a92c-85cf909a14d6" providerId="ADAL" clId="{F6FB32E6-F912-C242-8F3D-17E71D9B1660}" dt="2024-01-12T11:56:09.701" v="5" actId="1076"/>
        <pc:sldMkLst>
          <pc:docMk/>
          <pc:sldMk cId="2533011358" sldId="256"/>
        </pc:sldMkLst>
        <pc:picChg chg="add mod">
          <ac:chgData name="Qi PAN (20567662)" userId="bcbb93bd-4ab9-4583-a92c-85cf909a14d6" providerId="ADAL" clId="{F6FB32E6-F912-C242-8F3D-17E71D9B1660}" dt="2024-01-12T11:56:09.701" v="5" actId="1076"/>
          <ac:picMkLst>
            <pc:docMk/>
            <pc:sldMk cId="2533011358" sldId="256"/>
            <ac:picMk id="3" creationId="{C18A8153-07CC-CB2C-4415-82D9DF97250E}"/>
          </ac:picMkLst>
        </pc:picChg>
        <pc:picChg chg="del">
          <ac:chgData name="Qi PAN (20567662)" userId="bcbb93bd-4ab9-4583-a92c-85cf909a14d6" providerId="ADAL" clId="{F6FB32E6-F912-C242-8F3D-17E71D9B1660}" dt="2024-01-12T11:55:59.495" v="0" actId="478"/>
          <ac:picMkLst>
            <pc:docMk/>
            <pc:sldMk cId="2533011358" sldId="256"/>
            <ac:picMk id="5" creationId="{11CDB4D8-691A-A995-950A-437C7D02FCBB}"/>
          </ac:picMkLst>
        </pc:picChg>
      </pc:sldChg>
    </pc:docChg>
  </pc:docChgLst>
  <pc:docChgLst>
    <pc:chgData name="Qi PAN (20567662)" userId="bcbb93bd-4ab9-4583-a92c-85cf909a14d6" providerId="ADAL" clId="{95A9F937-45EB-B44D-984A-57074389ADD2}"/>
    <pc:docChg chg="custSel modSld">
      <pc:chgData name="Qi PAN (20567662)" userId="bcbb93bd-4ab9-4583-a92c-85cf909a14d6" providerId="ADAL" clId="{95A9F937-45EB-B44D-984A-57074389ADD2}" dt="2024-01-12T12:16:53.280" v="18" actId="1076"/>
      <pc:docMkLst>
        <pc:docMk/>
      </pc:docMkLst>
      <pc:sldChg chg="addSp delSp modSp mod">
        <pc:chgData name="Qi PAN (20567662)" userId="bcbb93bd-4ab9-4583-a92c-85cf909a14d6" providerId="ADAL" clId="{95A9F937-45EB-B44D-984A-57074389ADD2}" dt="2024-01-12T12:16:53.280" v="18" actId="1076"/>
        <pc:sldMkLst>
          <pc:docMk/>
          <pc:sldMk cId="2533011358" sldId="256"/>
        </pc:sldMkLst>
        <pc:spChg chg="add mod">
          <ac:chgData name="Qi PAN (20567662)" userId="bcbb93bd-4ab9-4583-a92c-85cf909a14d6" providerId="ADAL" clId="{95A9F937-45EB-B44D-984A-57074389ADD2}" dt="2024-01-12T12:16:53.280" v="18" actId="1076"/>
          <ac:spMkLst>
            <pc:docMk/>
            <pc:sldMk cId="2533011358" sldId="256"/>
            <ac:spMk id="5" creationId="{DADF1A3D-5AC1-CF99-678E-CBE7A119F193}"/>
          </ac:spMkLst>
        </pc:spChg>
        <pc:picChg chg="del">
          <ac:chgData name="Qi PAN (20567662)" userId="bcbb93bd-4ab9-4583-a92c-85cf909a14d6" providerId="ADAL" clId="{95A9F937-45EB-B44D-984A-57074389ADD2}" dt="2024-01-12T12:16:07.027" v="0" actId="478"/>
          <ac:picMkLst>
            <pc:docMk/>
            <pc:sldMk cId="2533011358" sldId="256"/>
            <ac:picMk id="3" creationId="{C18A8153-07CC-CB2C-4415-82D9DF97250E}"/>
          </ac:picMkLst>
        </pc:picChg>
        <pc:picChg chg="add mod">
          <ac:chgData name="Qi PAN (20567662)" userId="bcbb93bd-4ab9-4583-a92c-85cf909a14d6" providerId="ADAL" clId="{95A9F937-45EB-B44D-984A-57074389ADD2}" dt="2024-01-12T12:16:28.427" v="7" actId="1076"/>
          <ac:picMkLst>
            <pc:docMk/>
            <pc:sldMk cId="2533011358" sldId="256"/>
            <ac:picMk id="4" creationId="{30D6EE31-3C12-DE9D-18C4-915D09190F6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75DE37-DAB8-524A-36CE-1F562359EA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2227BDA-50A8-02E3-9C62-B89E3720EF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EAE99A-E347-8CED-CC4F-F23F7D5AD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5417AC-7E91-1791-FB35-B12E17481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C00D39-797D-920A-780E-86962487E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993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A6F028-A2D6-CAAE-B01E-6F9D86C2B5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9FC735B-3A6B-3BD8-83D7-8EE0E51A56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CDAB94-5493-FAFF-FE7A-6C2DADD7D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336C8A1-EA51-787D-5869-00704B267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2B64E8-C9A8-FFF3-2A70-198F5869D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5657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5DC3CFE-78B5-822E-7110-AB13E3CAA3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934B1FF-A3EB-F259-1F18-5BA208A846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F72761-F59D-E592-D7F4-93CFA5F1F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98B963-DB60-4D4C-7D72-115CCA333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2A720C-79F0-6617-C76B-9D3FD4711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771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E59864-36AB-0B12-F17F-E00E98B298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7794DE2-740E-638F-F417-BD95C11B50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8DD750-029A-DF56-2489-2AE6AB769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6D0A24-B7ED-0BB4-75E5-75EE2CE41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B41BC5-6D2E-6C4B-1973-A378C3F4C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707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2963ED-E577-B192-2186-2BA719E39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5AA342B-5D57-A3AA-EDB3-5074CBFA40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9D6DBC-C01A-8EB0-3AEB-163731B6C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9A19EF-765B-AA1B-B984-94053B0B6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888D3D-AB20-1C40-52F8-CBEF0A45B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9755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DCBAED-E3E4-ED56-4DC3-25B6641302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DE79B8D-7A21-E232-0396-FB92ED45E4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CBE58E5-3F41-AACF-F07B-1DFC8C9C09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243D13-DC3F-9BCF-06AE-FA0973994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2791BCD-AD75-6BF9-7B38-60FC89116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AD156C0-FBE9-45D7-1C7D-E34576DEA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9188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55ECCE-25A2-C4A1-CFC0-EEB68A3EA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231AF53-E7AF-61A2-BC88-CB69F18124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D48E305-08E4-26B5-8103-5E6D4D0830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8F03C23-3682-F820-9014-C9E3BF8D9D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BF98E60-F718-0062-2164-22EFE04CAB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A350F3D-8BDE-2FF5-39DC-A394F0CE6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3949AC5-9685-53AD-6042-083D15AD3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92F02D5-5985-E9CF-937D-B4DDE7EA5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655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3B95C7-DF33-F499-0655-5631B4A61F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DC79ABC-95AB-06A5-2F16-4AAD95DC8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BE7D470-6C20-F89D-CD2F-F4DF2F8AC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3371AB3-B251-1A96-2928-BE5E85734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2274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713F258-4F81-CDC7-5235-44EB1FB7E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D432ED2-32D0-77DE-43CA-ECF6F7AE2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D1A4048-829B-F19F-7A4C-B15332F78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71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A2BAC1-58DA-C371-ECA9-9463D6BD3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EC84DD-276D-9989-14E1-9B0F6A847A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A21B89A-DEA1-C529-8231-242D7F339C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A8B0EE-6A4F-9CB8-5240-57797DF03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8B5ECE-EBAC-80A3-2C8D-862198511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7EC5A5-2365-957D-E501-A55D3117D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8142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2969AF-6949-52F3-6720-C45C0E00CC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C38E1B7-2E58-B481-3D60-EE19E0BA84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1A0364A-44C5-129E-63F6-9486B2B005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62451A6-382A-FE67-4B60-DB6EC9775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F9F63F-74A5-F4E9-0FA1-EA7F430F3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C29F02-4977-BED6-652A-9B4457F7E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491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C3BFC56-3306-42DF-9593-8A63D2B69C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73064B6-ECAF-592E-ECEB-1EEFB91471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E109A8-FA92-CA31-1C35-AFFBAFD66C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F0F29F-0353-A97D-4E01-C099B4F979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621E45-031D-1655-5AA7-E5A8504209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664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595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rs9889282</a:t>
            </a:r>
            <a:endParaRPr kumimoji="1"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0829964-A189-3385-4AA0-B487E4A18D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075" y="1400982"/>
            <a:ext cx="11841849" cy="40560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30113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rs34291892</a:t>
            </a:r>
            <a:endParaRPr kumimoji="1"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187417DA-2FEA-970E-20C3-EAA26FCEA5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618" y="1860749"/>
            <a:ext cx="11020763" cy="31365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61955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rs13135092</a:t>
            </a:r>
            <a:endParaRPr kumimoji="1"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8D3A088-1C7B-6A39-40D0-99C3C92527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0960" y="1093415"/>
            <a:ext cx="5072532" cy="4671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47825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595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rs4608411</a:t>
            </a:r>
            <a:endParaRPr kumimoji="1"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F8EF2ED-8CBB-8A29-15A1-EE6ED534DB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3311" y="1478776"/>
            <a:ext cx="4399590" cy="39004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78033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852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rs370565192 </a:t>
            </a:r>
            <a:endParaRPr kumimoji="1"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AB77A31-F255-4746-73AE-EE4949A266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1149" y="1115891"/>
            <a:ext cx="6169702" cy="4626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89423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723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rs12951067</a:t>
            </a:r>
            <a:endParaRPr kumimoji="1"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033DA3C-CF4E-61DF-9D02-BD92CEBA56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1649" y="1185203"/>
            <a:ext cx="11448702" cy="44875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5247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8</Words>
  <Application>Microsoft Macintosh PowerPoint</Application>
  <PresentationFormat>宽屏</PresentationFormat>
  <Paragraphs>6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hua.meng</dc:creator>
  <cp:lastModifiedBy>Pan, Qi</cp:lastModifiedBy>
  <cp:revision>5</cp:revision>
  <dcterms:created xsi:type="dcterms:W3CDTF">2022-08-21T00:56:49Z</dcterms:created>
  <dcterms:modified xsi:type="dcterms:W3CDTF">2024-02-17T08:04:12Z</dcterms:modified>
</cp:coreProperties>
</file>